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1" r:id="rId2"/>
  </p:sldIdLst>
  <p:sldSz cx="12192000" cy="6858000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9999FF"/>
    <a:srgbClr val="0000FF"/>
    <a:srgbClr val="FF33CC"/>
    <a:srgbClr val="FFC000"/>
    <a:srgbClr val="FFCC99"/>
    <a:srgbClr val="00CCFF"/>
    <a:srgbClr val="6699FF"/>
    <a:srgbClr val="6666FF"/>
    <a:srgbClr val="99CCFF"/>
    <a:srgbClr val="CC99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horzBarState="maximized">
    <p:restoredLeft sz="14629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450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67D377B7-C823-472C-9E09-6D86554DC02C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717550" y="1162050"/>
            <a:ext cx="5575300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73892"/>
            <a:ext cx="5608320" cy="3660458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24F9BC96-858B-41C2-877C-3E56BFBCC5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77778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ARH-77 highest </a:t>
            </a:r>
            <a:r>
              <a:rPr lang="en-US" dirty="0">
                <a:sym typeface="Wingdings" pitchFamily="2" charset="2"/>
              </a:rPr>
              <a:t> lowest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3342E26-C62D-3D4E-A69D-E16CD71C934F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546741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20730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48891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96872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2090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4784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51218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6452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70106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40298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56530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60492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68365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43140" y="16901"/>
            <a:ext cx="85792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>
                <a:latin typeface="Arial" panose="020B0604020202020204" pitchFamily="34" charset="0"/>
                <a:cs typeface="Arial" panose="020B0604020202020204" pitchFamily="34" charset="0"/>
              </a:rPr>
              <a:t>Fig. S4</a:t>
            </a:r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4294" y="671079"/>
            <a:ext cx="6523992" cy="3523359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48286" y="655383"/>
            <a:ext cx="5173419" cy="3322997"/>
          </a:xfrm>
          <a:prstGeom prst="rect">
            <a:avLst/>
          </a:prstGeom>
        </p:spPr>
      </p:pic>
      <p:sp>
        <p:nvSpPr>
          <p:cNvPr id="10" name="TextBox 9"/>
          <p:cNvSpPr txBox="1"/>
          <p:nvPr/>
        </p:nvSpPr>
        <p:spPr>
          <a:xfrm>
            <a:off x="135277" y="493258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6540537" y="493258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</a:p>
        </p:txBody>
      </p:sp>
      <p:sp>
        <p:nvSpPr>
          <p:cNvPr id="2" name="Rectangle 1"/>
          <p:cNvSpPr/>
          <p:nvPr/>
        </p:nvSpPr>
        <p:spPr>
          <a:xfrm>
            <a:off x="224294" y="4210134"/>
            <a:ext cx="11883039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>
                <a:latin typeface="Times New Roman" panose="02020603050405020304" pitchFamily="18" charset="0"/>
                <a:ea typeface="Times New Roman" panose="02020603050405020304" pitchFamily="18" charset="0"/>
              </a:rPr>
              <a:t>Fig. S4. </a:t>
            </a:r>
            <a:r>
              <a:rPr lang="en-US" sz="1200" b="1">
                <a:solidFill>
                  <a:srgbClr val="C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a. </a:t>
            </a:r>
            <a:r>
              <a:rPr lang="en-US" sz="120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Effect of hits from the HTS on proteasome ChT-like activity on ARH-77 and U266 MMCLs. Proteasome ChT-like activity was determined with 50,000 ARHG-77 or U266 cells/well after 24 h of incubation with 50 uM LLVY-R110. </a:t>
            </a:r>
            <a:r>
              <a:rPr lang="en-US" sz="1200" b="1">
                <a:solidFill>
                  <a:srgbClr val="C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b.</a:t>
            </a:r>
            <a:r>
              <a:rPr lang="en-US" sz="1200">
                <a:solidFill>
                  <a:srgbClr val="C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120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Effect of proteasome inhibitors on proteasome ChT-like activity in three different MMCLs. Bortezomib, carfilzomib and ixazomib were added to MM cells at indicated concentrations. Proteasome ChT-like activity was then determined after 24 h incubation.</a:t>
            </a:r>
            <a:endParaRPr lang="en-US" sz="120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384935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394</TotalTime>
  <Words>95</Words>
  <Application>Microsoft Office PowerPoint</Application>
  <PresentationFormat>Widescreen</PresentationFormat>
  <Paragraphs>6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Wingdings</vt:lpstr>
      <vt:lpstr>Office Theme</vt:lpstr>
      <vt:lpstr>PowerPoint Presentation</vt:lpstr>
    </vt:vector>
  </TitlesOfParts>
  <Company>UHH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riscoll, James Joseph</dc:creator>
  <cp:lastModifiedBy>Driscoll, James Joseph</cp:lastModifiedBy>
  <cp:revision>100</cp:revision>
  <cp:lastPrinted>2024-03-02T18:31:01Z</cp:lastPrinted>
  <dcterms:created xsi:type="dcterms:W3CDTF">2022-08-15T18:48:13Z</dcterms:created>
  <dcterms:modified xsi:type="dcterms:W3CDTF">2024-05-03T22:01:43Z</dcterms:modified>
</cp:coreProperties>
</file>